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9436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8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2251" y="72"/>
      </p:cViewPr>
      <p:guideLst>
        <p:guide orient="horz" pos="2160"/>
        <p:guide pos="18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45770" y="1122363"/>
            <a:ext cx="5052060" cy="2387600"/>
          </a:xfrm>
        </p:spPr>
        <p:txBody>
          <a:bodyPr anchor="b"/>
          <a:lstStyle>
            <a:lvl1pPr algn="ctr">
              <a:defRPr sz="39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42950" y="3602038"/>
            <a:ext cx="4457700" cy="1655762"/>
          </a:xfrm>
        </p:spPr>
        <p:txBody>
          <a:bodyPr/>
          <a:lstStyle>
            <a:lvl1pPr marL="0" indent="0" algn="ctr">
              <a:buNone/>
              <a:defRPr sz="1560"/>
            </a:lvl1pPr>
            <a:lvl2pPr marL="297180" indent="0" algn="ctr">
              <a:buNone/>
              <a:defRPr sz="1300"/>
            </a:lvl2pPr>
            <a:lvl3pPr marL="594360" indent="0" algn="ctr">
              <a:buNone/>
              <a:defRPr sz="1170"/>
            </a:lvl3pPr>
            <a:lvl4pPr marL="891540" indent="0" algn="ctr">
              <a:buNone/>
              <a:defRPr sz="1040"/>
            </a:lvl4pPr>
            <a:lvl5pPr marL="1188720" indent="0" algn="ctr">
              <a:buNone/>
              <a:defRPr sz="1040"/>
            </a:lvl5pPr>
            <a:lvl6pPr marL="1485900" indent="0" algn="ctr">
              <a:buNone/>
              <a:defRPr sz="1040"/>
            </a:lvl6pPr>
            <a:lvl7pPr marL="1783080" indent="0" algn="ctr">
              <a:buNone/>
              <a:defRPr sz="1040"/>
            </a:lvl7pPr>
            <a:lvl8pPr marL="2080260" indent="0" algn="ctr">
              <a:buNone/>
              <a:defRPr sz="1040"/>
            </a:lvl8pPr>
            <a:lvl9pPr marL="2377440" indent="0" algn="ctr">
              <a:buNone/>
              <a:defRPr sz="10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80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079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53389" y="365125"/>
            <a:ext cx="1281589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8623" y="365125"/>
            <a:ext cx="3770471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35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314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5527" y="1709740"/>
            <a:ext cx="5126355" cy="2852737"/>
          </a:xfrm>
        </p:spPr>
        <p:txBody>
          <a:bodyPr anchor="b"/>
          <a:lstStyle>
            <a:lvl1pPr>
              <a:defRPr sz="39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5527" y="4589465"/>
            <a:ext cx="5126355" cy="1500187"/>
          </a:xfrm>
        </p:spPr>
        <p:txBody>
          <a:bodyPr/>
          <a:lstStyle>
            <a:lvl1pPr marL="0" indent="0">
              <a:buNone/>
              <a:defRPr sz="1560">
                <a:solidFill>
                  <a:schemeClr val="tx1"/>
                </a:solidFill>
              </a:defRPr>
            </a:lvl1pPr>
            <a:lvl2pPr marL="2971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594360" indent="0">
              <a:buNone/>
              <a:defRPr sz="1170">
                <a:solidFill>
                  <a:schemeClr val="tx1">
                    <a:tint val="75000"/>
                  </a:schemeClr>
                </a:solidFill>
              </a:defRPr>
            </a:lvl3pPr>
            <a:lvl4pPr marL="891540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4pPr>
            <a:lvl5pPr marL="1188720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5pPr>
            <a:lvl6pPr marL="1485900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6pPr>
            <a:lvl7pPr marL="1783080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7pPr>
            <a:lvl8pPr marL="2080260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8pPr>
            <a:lvl9pPr marL="2377440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118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8623" y="1825625"/>
            <a:ext cx="252603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08948" y="1825625"/>
            <a:ext cx="252603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742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397" y="365127"/>
            <a:ext cx="512635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9397" y="1681163"/>
            <a:ext cx="2514421" cy="823912"/>
          </a:xfrm>
        </p:spPr>
        <p:txBody>
          <a:bodyPr anchor="b"/>
          <a:lstStyle>
            <a:lvl1pPr marL="0" indent="0">
              <a:buNone/>
              <a:defRPr sz="1560" b="1"/>
            </a:lvl1pPr>
            <a:lvl2pPr marL="297180" indent="0">
              <a:buNone/>
              <a:defRPr sz="1300" b="1"/>
            </a:lvl2pPr>
            <a:lvl3pPr marL="594360" indent="0">
              <a:buNone/>
              <a:defRPr sz="1170" b="1"/>
            </a:lvl3pPr>
            <a:lvl4pPr marL="891540" indent="0">
              <a:buNone/>
              <a:defRPr sz="1040" b="1"/>
            </a:lvl4pPr>
            <a:lvl5pPr marL="1188720" indent="0">
              <a:buNone/>
              <a:defRPr sz="1040" b="1"/>
            </a:lvl5pPr>
            <a:lvl6pPr marL="1485900" indent="0">
              <a:buNone/>
              <a:defRPr sz="1040" b="1"/>
            </a:lvl6pPr>
            <a:lvl7pPr marL="1783080" indent="0">
              <a:buNone/>
              <a:defRPr sz="1040" b="1"/>
            </a:lvl7pPr>
            <a:lvl8pPr marL="2080260" indent="0">
              <a:buNone/>
              <a:defRPr sz="1040" b="1"/>
            </a:lvl8pPr>
            <a:lvl9pPr marL="2377440" indent="0">
              <a:buNone/>
              <a:defRPr sz="10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9397" y="2505075"/>
            <a:ext cx="251442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08948" y="1681163"/>
            <a:ext cx="2526804" cy="823912"/>
          </a:xfrm>
        </p:spPr>
        <p:txBody>
          <a:bodyPr anchor="b"/>
          <a:lstStyle>
            <a:lvl1pPr marL="0" indent="0">
              <a:buNone/>
              <a:defRPr sz="1560" b="1"/>
            </a:lvl1pPr>
            <a:lvl2pPr marL="297180" indent="0">
              <a:buNone/>
              <a:defRPr sz="1300" b="1"/>
            </a:lvl2pPr>
            <a:lvl3pPr marL="594360" indent="0">
              <a:buNone/>
              <a:defRPr sz="1170" b="1"/>
            </a:lvl3pPr>
            <a:lvl4pPr marL="891540" indent="0">
              <a:buNone/>
              <a:defRPr sz="1040" b="1"/>
            </a:lvl4pPr>
            <a:lvl5pPr marL="1188720" indent="0">
              <a:buNone/>
              <a:defRPr sz="1040" b="1"/>
            </a:lvl5pPr>
            <a:lvl6pPr marL="1485900" indent="0">
              <a:buNone/>
              <a:defRPr sz="1040" b="1"/>
            </a:lvl6pPr>
            <a:lvl7pPr marL="1783080" indent="0">
              <a:buNone/>
              <a:defRPr sz="1040" b="1"/>
            </a:lvl7pPr>
            <a:lvl8pPr marL="2080260" indent="0">
              <a:buNone/>
              <a:defRPr sz="1040" b="1"/>
            </a:lvl8pPr>
            <a:lvl9pPr marL="2377440" indent="0">
              <a:buNone/>
              <a:defRPr sz="10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08948" y="2505075"/>
            <a:ext cx="2526804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931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682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276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397" y="457200"/>
            <a:ext cx="1916966" cy="1600200"/>
          </a:xfrm>
        </p:spPr>
        <p:txBody>
          <a:bodyPr anchor="b"/>
          <a:lstStyle>
            <a:lvl1pPr>
              <a:defRPr sz="2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26804" y="987427"/>
            <a:ext cx="3008948" cy="4873625"/>
          </a:xfrm>
        </p:spPr>
        <p:txBody>
          <a:bodyPr/>
          <a:lstStyle>
            <a:lvl1pPr>
              <a:defRPr sz="2080"/>
            </a:lvl1pPr>
            <a:lvl2pPr>
              <a:defRPr sz="1820"/>
            </a:lvl2pPr>
            <a:lvl3pPr>
              <a:defRPr sz="156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9397" y="2057400"/>
            <a:ext cx="1916966" cy="3811588"/>
          </a:xfrm>
        </p:spPr>
        <p:txBody>
          <a:bodyPr/>
          <a:lstStyle>
            <a:lvl1pPr marL="0" indent="0">
              <a:buNone/>
              <a:defRPr sz="1040"/>
            </a:lvl1pPr>
            <a:lvl2pPr marL="297180" indent="0">
              <a:buNone/>
              <a:defRPr sz="910"/>
            </a:lvl2pPr>
            <a:lvl3pPr marL="594360" indent="0">
              <a:buNone/>
              <a:defRPr sz="780"/>
            </a:lvl3pPr>
            <a:lvl4pPr marL="891540" indent="0">
              <a:buNone/>
              <a:defRPr sz="650"/>
            </a:lvl4pPr>
            <a:lvl5pPr marL="1188720" indent="0">
              <a:buNone/>
              <a:defRPr sz="650"/>
            </a:lvl5pPr>
            <a:lvl6pPr marL="1485900" indent="0">
              <a:buNone/>
              <a:defRPr sz="650"/>
            </a:lvl6pPr>
            <a:lvl7pPr marL="1783080" indent="0">
              <a:buNone/>
              <a:defRPr sz="650"/>
            </a:lvl7pPr>
            <a:lvl8pPr marL="2080260" indent="0">
              <a:buNone/>
              <a:defRPr sz="650"/>
            </a:lvl8pPr>
            <a:lvl9pPr marL="2377440" indent="0">
              <a:buNone/>
              <a:defRPr sz="6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981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397" y="457200"/>
            <a:ext cx="1916966" cy="1600200"/>
          </a:xfrm>
        </p:spPr>
        <p:txBody>
          <a:bodyPr anchor="b"/>
          <a:lstStyle>
            <a:lvl1pPr>
              <a:defRPr sz="2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26804" y="987427"/>
            <a:ext cx="3008948" cy="4873625"/>
          </a:xfrm>
        </p:spPr>
        <p:txBody>
          <a:bodyPr anchor="t"/>
          <a:lstStyle>
            <a:lvl1pPr marL="0" indent="0">
              <a:buNone/>
              <a:defRPr sz="2080"/>
            </a:lvl1pPr>
            <a:lvl2pPr marL="297180" indent="0">
              <a:buNone/>
              <a:defRPr sz="1820"/>
            </a:lvl2pPr>
            <a:lvl3pPr marL="594360" indent="0">
              <a:buNone/>
              <a:defRPr sz="1560"/>
            </a:lvl3pPr>
            <a:lvl4pPr marL="891540" indent="0">
              <a:buNone/>
              <a:defRPr sz="1300"/>
            </a:lvl4pPr>
            <a:lvl5pPr marL="1188720" indent="0">
              <a:buNone/>
              <a:defRPr sz="1300"/>
            </a:lvl5pPr>
            <a:lvl6pPr marL="1485900" indent="0">
              <a:buNone/>
              <a:defRPr sz="1300"/>
            </a:lvl6pPr>
            <a:lvl7pPr marL="1783080" indent="0">
              <a:buNone/>
              <a:defRPr sz="1300"/>
            </a:lvl7pPr>
            <a:lvl8pPr marL="2080260" indent="0">
              <a:buNone/>
              <a:defRPr sz="1300"/>
            </a:lvl8pPr>
            <a:lvl9pPr marL="2377440" indent="0">
              <a:buNone/>
              <a:defRPr sz="13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9397" y="2057400"/>
            <a:ext cx="1916966" cy="3811588"/>
          </a:xfrm>
        </p:spPr>
        <p:txBody>
          <a:bodyPr/>
          <a:lstStyle>
            <a:lvl1pPr marL="0" indent="0">
              <a:buNone/>
              <a:defRPr sz="1040"/>
            </a:lvl1pPr>
            <a:lvl2pPr marL="297180" indent="0">
              <a:buNone/>
              <a:defRPr sz="910"/>
            </a:lvl2pPr>
            <a:lvl3pPr marL="594360" indent="0">
              <a:buNone/>
              <a:defRPr sz="780"/>
            </a:lvl3pPr>
            <a:lvl4pPr marL="891540" indent="0">
              <a:buNone/>
              <a:defRPr sz="650"/>
            </a:lvl4pPr>
            <a:lvl5pPr marL="1188720" indent="0">
              <a:buNone/>
              <a:defRPr sz="650"/>
            </a:lvl5pPr>
            <a:lvl6pPr marL="1485900" indent="0">
              <a:buNone/>
              <a:defRPr sz="650"/>
            </a:lvl6pPr>
            <a:lvl7pPr marL="1783080" indent="0">
              <a:buNone/>
              <a:defRPr sz="650"/>
            </a:lvl7pPr>
            <a:lvl8pPr marL="2080260" indent="0">
              <a:buNone/>
              <a:defRPr sz="650"/>
            </a:lvl8pPr>
            <a:lvl9pPr marL="2377440" indent="0">
              <a:buNone/>
              <a:defRPr sz="6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191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8623" y="365127"/>
            <a:ext cx="512635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8623" y="1825625"/>
            <a:ext cx="512635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8623" y="6356352"/>
            <a:ext cx="13373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F6E9A-DD61-469E-A008-2BB277E74AAA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68818" y="6356352"/>
            <a:ext cx="200596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97668" y="6356352"/>
            <a:ext cx="13373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E724B-4D59-4A34-9DE1-232DAF3215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290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94360" rtl="0" eaLnBrk="1" latinLnBrk="0" hangingPunct="1">
        <a:lnSpc>
          <a:spcPct val="90000"/>
        </a:lnSpc>
        <a:spcBef>
          <a:spcPct val="0"/>
        </a:spcBef>
        <a:buNone/>
        <a:defRPr sz="28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8590" indent="-148590" algn="l" defTabSz="59436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1820" kern="1200">
          <a:solidFill>
            <a:schemeClr val="tx1"/>
          </a:solidFill>
          <a:latin typeface="+mn-lt"/>
          <a:ea typeface="+mn-ea"/>
          <a:cs typeface="+mn-cs"/>
        </a:defRPr>
      </a:lvl1pPr>
      <a:lvl2pPr marL="44577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2pPr>
      <a:lvl3pPr marL="74295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4013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70" kern="1200">
          <a:solidFill>
            <a:schemeClr val="tx1"/>
          </a:solidFill>
          <a:latin typeface="+mn-lt"/>
          <a:ea typeface="+mn-ea"/>
          <a:cs typeface="+mn-cs"/>
        </a:defRPr>
      </a:lvl4pPr>
      <a:lvl5pPr marL="133731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70" kern="1200">
          <a:solidFill>
            <a:schemeClr val="tx1"/>
          </a:solidFill>
          <a:latin typeface="+mn-lt"/>
          <a:ea typeface="+mn-ea"/>
          <a:cs typeface="+mn-cs"/>
        </a:defRPr>
      </a:lvl5pPr>
      <a:lvl6pPr marL="163449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70" kern="1200">
          <a:solidFill>
            <a:schemeClr val="tx1"/>
          </a:solidFill>
          <a:latin typeface="+mn-lt"/>
          <a:ea typeface="+mn-ea"/>
          <a:cs typeface="+mn-cs"/>
        </a:defRPr>
      </a:lvl6pPr>
      <a:lvl7pPr marL="193167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70" kern="1200">
          <a:solidFill>
            <a:schemeClr val="tx1"/>
          </a:solidFill>
          <a:latin typeface="+mn-lt"/>
          <a:ea typeface="+mn-ea"/>
          <a:cs typeface="+mn-cs"/>
        </a:defRPr>
      </a:lvl7pPr>
      <a:lvl8pPr marL="222885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70" kern="1200">
          <a:solidFill>
            <a:schemeClr val="tx1"/>
          </a:solidFill>
          <a:latin typeface="+mn-lt"/>
          <a:ea typeface="+mn-ea"/>
          <a:cs typeface="+mn-cs"/>
        </a:defRPr>
      </a:lvl8pPr>
      <a:lvl9pPr marL="2526030" indent="-148590" algn="l" defTabSz="594360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7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1pPr>
      <a:lvl2pPr marL="29718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2pPr>
      <a:lvl3pPr marL="59436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3pPr>
      <a:lvl4pPr marL="89154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4pPr>
      <a:lvl5pPr marL="118872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5pPr>
      <a:lvl6pPr marL="148590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7pPr>
      <a:lvl8pPr marL="208026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8pPr>
      <a:lvl9pPr marL="2377440" algn="l" defTabSz="594360" rtl="0" eaLnBrk="1" latinLnBrk="0" hangingPunct="1">
        <a:defRPr sz="117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itting, night, light, dark&#10;&#10;Description automatically generated">
            <a:extLst>
              <a:ext uri="{FF2B5EF4-FFF2-40B4-BE49-F238E27FC236}">
                <a16:creationId xmlns:a16="http://schemas.microsoft.com/office/drawing/2014/main" id="{EC24317F-7797-4108-8633-6B5035AA0F9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59" b="57637"/>
          <a:stretch/>
        </p:blipFill>
        <p:spPr>
          <a:xfrm>
            <a:off x="276945" y="701136"/>
            <a:ext cx="5398991" cy="1428607"/>
          </a:xfrm>
          <a:prstGeom prst="rect">
            <a:avLst/>
          </a:prstGeom>
        </p:spPr>
      </p:pic>
      <p:pic>
        <p:nvPicPr>
          <p:cNvPr id="9" name="Picture 8" descr="A picture containing sitting, light, computer, black&#10;&#10;Description automatically generated">
            <a:extLst>
              <a:ext uri="{FF2B5EF4-FFF2-40B4-BE49-F238E27FC236}">
                <a16:creationId xmlns:a16="http://schemas.microsoft.com/office/drawing/2014/main" id="{A23846CF-4FD1-4021-820F-C67D6F702B4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59" b="57637"/>
          <a:stretch/>
        </p:blipFill>
        <p:spPr>
          <a:xfrm>
            <a:off x="276937" y="4090299"/>
            <a:ext cx="5398999" cy="142860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6FE14C9-BBC3-4E79-8474-9BC5F617D533}"/>
              </a:ext>
            </a:extLst>
          </p:cNvPr>
          <p:cNvSpPr txBox="1"/>
          <p:nvPr/>
        </p:nvSpPr>
        <p:spPr>
          <a:xfrm>
            <a:off x="80168" y="247985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V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ED1EAAC-8AF7-4B0A-AABA-E06A18D3D72E}"/>
              </a:ext>
            </a:extLst>
          </p:cNvPr>
          <p:cNvSpPr txBox="1"/>
          <p:nvPr/>
        </p:nvSpPr>
        <p:spPr>
          <a:xfrm>
            <a:off x="82094" y="3627507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V9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F879DB6-B1B1-480E-BEEF-951984B880A8}"/>
              </a:ext>
            </a:extLst>
          </p:cNvPr>
          <p:cNvCxnSpPr/>
          <p:nvPr/>
        </p:nvCxnSpPr>
        <p:spPr>
          <a:xfrm flipV="1">
            <a:off x="663635" y="392431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A7944D8-D739-4B63-9FAA-73E0AE301D7F}"/>
              </a:ext>
            </a:extLst>
          </p:cNvPr>
          <p:cNvCxnSpPr/>
          <p:nvPr/>
        </p:nvCxnSpPr>
        <p:spPr>
          <a:xfrm flipV="1">
            <a:off x="2835335" y="392431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D1F342C-2A72-4AFE-A4B7-6D351A92E61C}"/>
              </a:ext>
            </a:extLst>
          </p:cNvPr>
          <p:cNvCxnSpPr/>
          <p:nvPr/>
        </p:nvCxnSpPr>
        <p:spPr>
          <a:xfrm>
            <a:off x="663636" y="493396"/>
            <a:ext cx="2175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68ECF2E-3115-480F-B149-8A408D01CB84}"/>
              </a:ext>
            </a:extLst>
          </p:cNvPr>
          <p:cNvCxnSpPr/>
          <p:nvPr/>
        </p:nvCxnSpPr>
        <p:spPr>
          <a:xfrm flipV="1">
            <a:off x="3105846" y="392431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915BC00E-249A-4F11-A461-F4BAEF1C76A5}"/>
              </a:ext>
            </a:extLst>
          </p:cNvPr>
          <p:cNvCxnSpPr/>
          <p:nvPr/>
        </p:nvCxnSpPr>
        <p:spPr>
          <a:xfrm flipV="1">
            <a:off x="5277544" y="392431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B804AA45-80F8-4E62-A702-DB93986F7294}"/>
              </a:ext>
            </a:extLst>
          </p:cNvPr>
          <p:cNvCxnSpPr/>
          <p:nvPr/>
        </p:nvCxnSpPr>
        <p:spPr>
          <a:xfrm>
            <a:off x="3105847" y="493396"/>
            <a:ext cx="2175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B229E9B0-6A9E-4920-9BE7-85F53257A871}"/>
              </a:ext>
            </a:extLst>
          </p:cNvPr>
          <p:cNvCxnSpPr/>
          <p:nvPr/>
        </p:nvCxnSpPr>
        <p:spPr>
          <a:xfrm flipV="1">
            <a:off x="663635" y="3770045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247E954-E5BB-4A94-8B71-66264AEA722A}"/>
              </a:ext>
            </a:extLst>
          </p:cNvPr>
          <p:cNvCxnSpPr/>
          <p:nvPr/>
        </p:nvCxnSpPr>
        <p:spPr>
          <a:xfrm flipV="1">
            <a:off x="2835335" y="3770045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BEC72419-6BBA-47E7-A951-28F17E96C977}"/>
              </a:ext>
            </a:extLst>
          </p:cNvPr>
          <p:cNvCxnSpPr/>
          <p:nvPr/>
        </p:nvCxnSpPr>
        <p:spPr>
          <a:xfrm>
            <a:off x="663636" y="3871008"/>
            <a:ext cx="2175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175F605-6C94-4415-80D4-492BD1F95EBB}"/>
              </a:ext>
            </a:extLst>
          </p:cNvPr>
          <p:cNvCxnSpPr/>
          <p:nvPr/>
        </p:nvCxnSpPr>
        <p:spPr>
          <a:xfrm flipV="1">
            <a:off x="3105846" y="3770045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11C8EECA-4C95-4574-97A2-6282844E21E4}"/>
              </a:ext>
            </a:extLst>
          </p:cNvPr>
          <p:cNvCxnSpPr>
            <a:cxnSpLocks/>
          </p:cNvCxnSpPr>
          <p:nvPr/>
        </p:nvCxnSpPr>
        <p:spPr>
          <a:xfrm flipV="1">
            <a:off x="5277544" y="3770045"/>
            <a:ext cx="0" cy="2019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9399407-DA55-473F-BD0A-40C1F95C1BEE}"/>
              </a:ext>
            </a:extLst>
          </p:cNvPr>
          <p:cNvCxnSpPr/>
          <p:nvPr/>
        </p:nvCxnSpPr>
        <p:spPr>
          <a:xfrm>
            <a:off x="3105847" y="3871008"/>
            <a:ext cx="2175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AB2D67AC-BC2D-4520-B629-16A84174F054}"/>
              </a:ext>
            </a:extLst>
          </p:cNvPr>
          <p:cNvSpPr txBox="1"/>
          <p:nvPr/>
        </p:nvSpPr>
        <p:spPr>
          <a:xfrm>
            <a:off x="1210484" y="123170"/>
            <a:ext cx="1120820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>
                <a:latin typeface="Arial" panose="020B0604020202020204" pitchFamily="34" charset="0"/>
                <a:cs typeface="Arial" panose="020B0604020202020204" pitchFamily="34" charset="0"/>
              </a:rPr>
              <a:t>no clamp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DA34D00-1B41-4F79-B6EC-87B448B5C1E3}"/>
              </a:ext>
            </a:extLst>
          </p:cNvPr>
          <p:cNvSpPr txBox="1"/>
          <p:nvPr/>
        </p:nvSpPr>
        <p:spPr>
          <a:xfrm>
            <a:off x="3740324" y="123170"/>
            <a:ext cx="89479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>
                <a:latin typeface="Arial" panose="020B0604020202020204" pitchFamily="34" charset="0"/>
                <a:cs typeface="Arial" panose="020B0604020202020204" pitchFamily="34" charset="0"/>
              </a:rPr>
              <a:t>1.5 µM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379A0BE-3F3C-44B9-A916-69BAE2EACCA7}"/>
              </a:ext>
            </a:extLst>
          </p:cNvPr>
          <p:cNvSpPr txBox="1"/>
          <p:nvPr/>
        </p:nvSpPr>
        <p:spPr>
          <a:xfrm>
            <a:off x="1210484" y="3498830"/>
            <a:ext cx="1120820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>
                <a:latin typeface="Arial" panose="020B0604020202020204" pitchFamily="34" charset="0"/>
                <a:cs typeface="Arial" panose="020B0604020202020204" pitchFamily="34" charset="0"/>
              </a:rPr>
              <a:t>no clam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AF015F1-9F0E-4C57-993A-D740F0FF17C9}"/>
              </a:ext>
            </a:extLst>
          </p:cNvPr>
          <p:cNvSpPr txBox="1"/>
          <p:nvPr/>
        </p:nvSpPr>
        <p:spPr>
          <a:xfrm>
            <a:off x="3740324" y="3498830"/>
            <a:ext cx="89479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>
                <a:latin typeface="Arial" panose="020B0604020202020204" pitchFamily="34" charset="0"/>
                <a:cs typeface="Arial" panose="020B0604020202020204" pitchFamily="34" charset="0"/>
              </a:rPr>
              <a:t>1.5 µM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88A975F-B6DB-4A86-ABBA-FC9320C465E7}"/>
              </a:ext>
            </a:extLst>
          </p:cNvPr>
          <p:cNvSpPr txBox="1"/>
          <p:nvPr/>
        </p:nvSpPr>
        <p:spPr>
          <a:xfrm rot="16200000">
            <a:off x="475493" y="230124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ize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BF4D673-5F78-4A22-A856-0E882C9ADDF3}"/>
              </a:ext>
            </a:extLst>
          </p:cNvPr>
          <p:cNvSpPr txBox="1"/>
          <p:nvPr/>
        </p:nvSpPr>
        <p:spPr>
          <a:xfrm rot="16200000">
            <a:off x="807906" y="2217423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ice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CB38F4A-441F-4DC8-BCE9-80890BC07B57}"/>
              </a:ext>
            </a:extLst>
          </p:cNvPr>
          <p:cNvSpPr txBox="1"/>
          <p:nvPr/>
        </p:nvSpPr>
        <p:spPr>
          <a:xfrm rot="16200000">
            <a:off x="978414" y="230124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heat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946FE07-F3DA-447C-BEB0-776F194F1C8D}"/>
              </a:ext>
            </a:extLst>
          </p:cNvPr>
          <p:cNvSpPr txBox="1"/>
          <p:nvPr/>
        </p:nvSpPr>
        <p:spPr>
          <a:xfrm rot="16200000">
            <a:off x="1233488" y="2301242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rley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E462072-C9C3-4D67-A32A-8646DE3171C0}"/>
              </a:ext>
            </a:extLst>
          </p:cNvPr>
          <p:cNvSpPr txBox="1"/>
          <p:nvPr/>
        </p:nvSpPr>
        <p:spPr>
          <a:xfrm rot="16200000">
            <a:off x="1379941" y="2392682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orghum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580CF59-97CD-40B2-B403-9B6D1D098843}"/>
              </a:ext>
            </a:extLst>
          </p:cNvPr>
          <p:cNvSpPr txBox="1"/>
          <p:nvPr/>
        </p:nvSpPr>
        <p:spPr>
          <a:xfrm rot="16200000">
            <a:off x="1792770" y="2456005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. thalian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466E19F-B62A-42E4-BA6B-F061563626FB}"/>
              </a:ext>
            </a:extLst>
          </p:cNvPr>
          <p:cNvSpPr txBox="1"/>
          <p:nvPr/>
        </p:nvSpPr>
        <p:spPr>
          <a:xfrm rot="16200000">
            <a:off x="1376086" y="2624592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629F36E-FD19-4601-B0F4-6996B72CC762}"/>
              </a:ext>
            </a:extLst>
          </p:cNvPr>
          <p:cNvSpPr txBox="1"/>
          <p:nvPr/>
        </p:nvSpPr>
        <p:spPr>
          <a:xfrm rot="16200000">
            <a:off x="2240959" y="224971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C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7ED0DD0-5B5D-4EA6-9BE5-CCFDF0B310A3}"/>
              </a:ext>
            </a:extLst>
          </p:cNvPr>
          <p:cNvSpPr txBox="1"/>
          <p:nvPr/>
        </p:nvSpPr>
        <p:spPr>
          <a:xfrm rot="16200000">
            <a:off x="2101981" y="2633864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CC34CF7-91FC-4301-9EC5-AF77257E7F1D}"/>
              </a:ext>
            </a:extLst>
          </p:cNvPr>
          <p:cNvSpPr txBox="1"/>
          <p:nvPr/>
        </p:nvSpPr>
        <p:spPr>
          <a:xfrm rot="16200000">
            <a:off x="2921514" y="230124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ize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E59BAEB-69FF-4903-810D-1FDFEEF5717E}"/>
              </a:ext>
            </a:extLst>
          </p:cNvPr>
          <p:cNvSpPr txBox="1"/>
          <p:nvPr/>
        </p:nvSpPr>
        <p:spPr>
          <a:xfrm rot="16200000">
            <a:off x="3253926" y="2217423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ice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5637374-500A-4C87-AF6E-BF85BB8C7D6C}"/>
              </a:ext>
            </a:extLst>
          </p:cNvPr>
          <p:cNvSpPr txBox="1"/>
          <p:nvPr/>
        </p:nvSpPr>
        <p:spPr>
          <a:xfrm rot="16200000">
            <a:off x="3424435" y="230124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heat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35E741D-B04D-475E-83DF-C133163BF34B}"/>
              </a:ext>
            </a:extLst>
          </p:cNvPr>
          <p:cNvSpPr txBox="1"/>
          <p:nvPr/>
        </p:nvSpPr>
        <p:spPr>
          <a:xfrm rot="16200000">
            <a:off x="3679509" y="2301242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rley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347B51C-A95D-4D2F-A4AA-1EEABFAB1907}"/>
              </a:ext>
            </a:extLst>
          </p:cNvPr>
          <p:cNvSpPr txBox="1"/>
          <p:nvPr/>
        </p:nvSpPr>
        <p:spPr>
          <a:xfrm rot="16200000">
            <a:off x="3825960" y="2392682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orghum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82E53EF-B8D0-4468-9FE6-809882E5FB74}"/>
              </a:ext>
            </a:extLst>
          </p:cNvPr>
          <p:cNvSpPr txBox="1"/>
          <p:nvPr/>
        </p:nvSpPr>
        <p:spPr>
          <a:xfrm rot="16200000">
            <a:off x="4238792" y="2456005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. thaliana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042D84D-C8C2-408D-B595-401C9A3A7B60}"/>
              </a:ext>
            </a:extLst>
          </p:cNvPr>
          <p:cNvSpPr txBox="1"/>
          <p:nvPr/>
        </p:nvSpPr>
        <p:spPr>
          <a:xfrm rot="16200000">
            <a:off x="3822108" y="2624592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FC4FA63-302D-4027-8269-9C131E9D3ABA}"/>
              </a:ext>
            </a:extLst>
          </p:cNvPr>
          <p:cNvSpPr txBox="1"/>
          <p:nvPr/>
        </p:nvSpPr>
        <p:spPr>
          <a:xfrm rot="16200000">
            <a:off x="4686979" y="224971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C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2EBE0AA0-48F9-4685-A45B-8A84E8729994}"/>
              </a:ext>
            </a:extLst>
          </p:cNvPr>
          <p:cNvSpPr txBox="1"/>
          <p:nvPr/>
        </p:nvSpPr>
        <p:spPr>
          <a:xfrm rot="16200000">
            <a:off x="4548002" y="2633864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5B17267-BC09-4D2A-ABF8-1E345401A6D2}"/>
              </a:ext>
            </a:extLst>
          </p:cNvPr>
          <p:cNvSpPr txBox="1"/>
          <p:nvPr/>
        </p:nvSpPr>
        <p:spPr>
          <a:xfrm rot="16200000">
            <a:off x="475493" y="569214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ize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DE374A3C-9F57-47C1-9FFD-A44D095EABEF}"/>
              </a:ext>
            </a:extLst>
          </p:cNvPr>
          <p:cNvSpPr txBox="1"/>
          <p:nvPr/>
        </p:nvSpPr>
        <p:spPr>
          <a:xfrm rot="16200000">
            <a:off x="807906" y="5608323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ice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AFD9AFC-9051-4688-83CA-2632BEC7422C}"/>
              </a:ext>
            </a:extLst>
          </p:cNvPr>
          <p:cNvSpPr txBox="1"/>
          <p:nvPr/>
        </p:nvSpPr>
        <p:spPr>
          <a:xfrm rot="16200000">
            <a:off x="978414" y="569214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heat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BBEDFC5-93B6-49BA-990D-8EDFEF80D13F}"/>
              </a:ext>
            </a:extLst>
          </p:cNvPr>
          <p:cNvSpPr txBox="1"/>
          <p:nvPr/>
        </p:nvSpPr>
        <p:spPr>
          <a:xfrm rot="16200000">
            <a:off x="1233488" y="569214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rley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76034FC-73B8-4549-A352-22719649D262}"/>
              </a:ext>
            </a:extLst>
          </p:cNvPr>
          <p:cNvSpPr txBox="1"/>
          <p:nvPr/>
        </p:nvSpPr>
        <p:spPr>
          <a:xfrm rot="16200000">
            <a:off x="1379941" y="5783583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orghum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DAE76842-A3EF-437D-951A-A0E5F67126AD}"/>
              </a:ext>
            </a:extLst>
          </p:cNvPr>
          <p:cNvSpPr txBox="1"/>
          <p:nvPr/>
        </p:nvSpPr>
        <p:spPr>
          <a:xfrm rot="16200000">
            <a:off x="1792770" y="5846906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. thaliana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3136AE8-4ADF-47DF-A3C5-4C350B2B2A81}"/>
              </a:ext>
            </a:extLst>
          </p:cNvPr>
          <p:cNvSpPr txBox="1"/>
          <p:nvPr/>
        </p:nvSpPr>
        <p:spPr>
          <a:xfrm rot="16200000">
            <a:off x="1376086" y="6015492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0D1AB5F-FFFA-4D8B-9B72-A488F3BAD00B}"/>
              </a:ext>
            </a:extLst>
          </p:cNvPr>
          <p:cNvSpPr txBox="1"/>
          <p:nvPr/>
        </p:nvSpPr>
        <p:spPr>
          <a:xfrm rot="16200000">
            <a:off x="2240959" y="564061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C1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72EF05F-265E-4668-AC88-DCFB11B72E69}"/>
              </a:ext>
            </a:extLst>
          </p:cNvPr>
          <p:cNvSpPr txBox="1"/>
          <p:nvPr/>
        </p:nvSpPr>
        <p:spPr>
          <a:xfrm rot="16200000">
            <a:off x="2101981" y="6024764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BBEEF1E0-C988-4C60-9770-3FE94EB4C9AC}"/>
              </a:ext>
            </a:extLst>
          </p:cNvPr>
          <p:cNvSpPr txBox="1"/>
          <p:nvPr/>
        </p:nvSpPr>
        <p:spPr>
          <a:xfrm rot="16200000">
            <a:off x="2921514" y="569214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ize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B8A62444-B2AF-474B-96AF-CBC31012886D}"/>
              </a:ext>
            </a:extLst>
          </p:cNvPr>
          <p:cNvSpPr txBox="1"/>
          <p:nvPr/>
        </p:nvSpPr>
        <p:spPr>
          <a:xfrm rot="16200000">
            <a:off x="3253926" y="5608323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ic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DFE1C4A3-CEED-40F3-9D03-FF1E0831720D}"/>
              </a:ext>
            </a:extLst>
          </p:cNvPr>
          <p:cNvSpPr txBox="1"/>
          <p:nvPr/>
        </p:nvSpPr>
        <p:spPr>
          <a:xfrm rot="16200000">
            <a:off x="3424435" y="569214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heat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0D9C72D7-1DE6-4F23-A74E-8548EBDA24E3}"/>
              </a:ext>
            </a:extLst>
          </p:cNvPr>
          <p:cNvSpPr txBox="1"/>
          <p:nvPr/>
        </p:nvSpPr>
        <p:spPr>
          <a:xfrm rot="16200000">
            <a:off x="3679509" y="569214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rley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01F6FD0-DEEB-45A2-B4F6-C1D4998B3049}"/>
              </a:ext>
            </a:extLst>
          </p:cNvPr>
          <p:cNvSpPr txBox="1"/>
          <p:nvPr/>
        </p:nvSpPr>
        <p:spPr>
          <a:xfrm rot="16200000">
            <a:off x="3825960" y="5783583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orghum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74E42D59-E534-41C4-8490-F67B83054347}"/>
              </a:ext>
            </a:extLst>
          </p:cNvPr>
          <p:cNvSpPr txBox="1"/>
          <p:nvPr/>
        </p:nvSpPr>
        <p:spPr>
          <a:xfrm rot="16200000">
            <a:off x="4238792" y="5846906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. thaliana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50FCEE3B-F489-457C-B607-C5FA51786D75}"/>
              </a:ext>
            </a:extLst>
          </p:cNvPr>
          <p:cNvSpPr txBox="1"/>
          <p:nvPr/>
        </p:nvSpPr>
        <p:spPr>
          <a:xfrm rot="16200000">
            <a:off x="3822108" y="6015492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9F6AB5E3-F63E-407B-9BDA-028DAA80A9DD}"/>
              </a:ext>
            </a:extLst>
          </p:cNvPr>
          <p:cNvSpPr txBox="1"/>
          <p:nvPr/>
        </p:nvSpPr>
        <p:spPr>
          <a:xfrm rot="16200000">
            <a:off x="4686979" y="564061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C1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7C4CB5B8-D6E9-485A-92A7-2BF894D503D4}"/>
              </a:ext>
            </a:extLst>
          </p:cNvPr>
          <p:cNvSpPr txBox="1"/>
          <p:nvPr/>
        </p:nvSpPr>
        <p:spPr>
          <a:xfrm rot="16200000">
            <a:off x="4548002" y="6024764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</a:p>
        </p:txBody>
      </p:sp>
    </p:spTree>
    <p:extLst>
      <p:ext uri="{BB962C8B-B14F-4D97-AF65-F5344CB8AC3E}">
        <p14:creationId xmlns:p14="http://schemas.microsoft.com/office/powerpoint/2010/main" val="3194374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</TotalTime>
  <Words>66</Words>
  <Application>Microsoft Office PowerPoint</Application>
  <PresentationFormat>Custom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J. Taerum</dc:creator>
  <cp:lastModifiedBy>Stephen J. Taerum</cp:lastModifiedBy>
  <cp:revision>12</cp:revision>
  <dcterms:created xsi:type="dcterms:W3CDTF">2020-04-14T17:33:16Z</dcterms:created>
  <dcterms:modified xsi:type="dcterms:W3CDTF">2020-04-22T16:50:54Z</dcterms:modified>
</cp:coreProperties>
</file>